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4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C4CC7D-71EE-467F-BB7C-A060F0AE7442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9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7EA6910-8EC7-4C64-836C-2F29BE1D420E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8F923-527F-4A9C-98C6-E2244E7884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677E30-B5C1-46D6-9777-90412D65702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130929-DD88-4521-8D7F-231BA5D5CCE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F9DD1A-D0BD-404D-B9A3-830B9C28830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3A6BE7-4CB1-4DED-8FBC-4FC7E5433F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D387AA-E8C3-440B-A447-ADDA103EDCB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347560-7123-4CE2-8F69-7A84D82CFAB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BF8806-4F4C-4C70-B29F-BC3FD4A051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EE5A01-8D40-406A-AF94-5DD29CF451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5B140C-BC42-40D4-84BC-651D7AA384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34FE2D-9C6A-45A1-A2CB-05D0CD9BA7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1B243D-B93F-4825-820F-C1AD7C7EE7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56FBB55-6907-4E47-BB20-100CDFEB1AFE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slideLayout" Target="../slideLayouts/slideLayout1.xml"/><Relationship Id="rId2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F:\油料所工作\BAS20605.tif"/>
          <p:cNvPicPr/>
          <p:nvPr/>
        </p:nvPicPr>
        <p:blipFill>
          <a:blip r:embed="rId1"/>
          <a:stretch/>
        </p:blipFill>
        <p:spPr>
          <a:xfrm>
            <a:off x="272880" y="993600"/>
            <a:ext cx="1536840" cy="311400"/>
          </a:xfrm>
          <a:prstGeom prst="rect">
            <a:avLst/>
          </a:prstGeom>
          <a:ln w="0">
            <a:noFill/>
          </a:ln>
        </p:spPr>
      </p:pic>
      <p:sp>
        <p:nvSpPr>
          <p:cNvPr id="49" name="TextBox 8"/>
          <p:cNvSpPr/>
          <p:nvPr/>
        </p:nvSpPr>
        <p:spPr>
          <a:xfrm>
            <a:off x="30240" y="28584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组合 9"/>
          <p:cNvGrpSpPr/>
          <p:nvPr/>
        </p:nvGrpSpPr>
        <p:grpSpPr>
          <a:xfrm>
            <a:off x="965880" y="1217520"/>
            <a:ext cx="839880" cy="830520"/>
            <a:chOff x="965880" y="1217520"/>
            <a:chExt cx="839880" cy="830520"/>
          </a:xfrm>
        </p:grpSpPr>
        <p:sp>
          <p:nvSpPr>
            <p:cNvPr id="51" name="文本框 155"/>
            <p:cNvSpPr/>
            <p:nvPr/>
          </p:nvSpPr>
          <p:spPr>
            <a:xfrm rot="5400000">
              <a:off x="662040" y="1521000"/>
              <a:ext cx="822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wsc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 DAF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文本框 156"/>
            <p:cNvSpPr/>
            <p:nvPr/>
          </p:nvSpPr>
          <p:spPr>
            <a:xfrm rot="5400000">
              <a:off x="794520" y="1524600"/>
              <a:ext cx="822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wsc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 DAF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文本框 157"/>
            <p:cNvSpPr/>
            <p:nvPr/>
          </p:nvSpPr>
          <p:spPr>
            <a:xfrm rot="5400000">
              <a:off x="899280" y="1528560"/>
              <a:ext cx="822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wsc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 DAF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文本框 158"/>
            <p:cNvSpPr/>
            <p:nvPr/>
          </p:nvSpPr>
          <p:spPr>
            <a:xfrm rot="5400000">
              <a:off x="1008360" y="1524600"/>
              <a:ext cx="822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WT DAF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文本框 159"/>
            <p:cNvSpPr/>
            <p:nvPr/>
          </p:nvSpPr>
          <p:spPr>
            <a:xfrm rot="5400000">
              <a:off x="1162800" y="1523880"/>
              <a:ext cx="822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WT DAF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文本框 160"/>
            <p:cNvSpPr/>
            <p:nvPr/>
          </p:nvSpPr>
          <p:spPr>
            <a:xfrm rot="5400000">
              <a:off x="1286280" y="1523880"/>
              <a:ext cx="822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WT DAF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" name="右大括号 16"/>
          <p:cNvSpPr/>
          <p:nvPr/>
        </p:nvSpPr>
        <p:spPr>
          <a:xfrm>
            <a:off x="2714760" y="593640"/>
            <a:ext cx="142920" cy="378000"/>
          </a:xfrm>
          <a:custGeom>
            <a:avLst/>
            <a:gdLst>
              <a:gd name="textAreaLeft" fmla="*/ 0 w 142920"/>
              <a:gd name="textAreaRight" fmla="*/ 51480 w 142920"/>
              <a:gd name="textAreaTop" fmla="*/ 3600 h 378000"/>
              <a:gd name="textAreaBottom" fmla="*/ 374400 h 37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41"/>
                  <a:pt x="10800" y="681"/>
                </a:cubicBezTo>
                <a:lnTo>
                  <a:pt x="10800" y="10119"/>
                </a:lnTo>
                <a:cubicBezTo>
                  <a:pt x="10800" y="10460"/>
                  <a:pt x="16200" y="10800"/>
                  <a:pt x="21600" y="10800"/>
                </a:cubicBezTo>
                <a:cubicBezTo>
                  <a:pt x="16200" y="10800"/>
                  <a:pt x="10800" y="11141"/>
                  <a:pt x="10800" y="11481"/>
                </a:cubicBezTo>
                <a:lnTo>
                  <a:pt x="10800" y="20919"/>
                </a:lnTo>
                <a:cubicBezTo>
                  <a:pt x="10800" y="2126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矩形 17"/>
          <p:cNvSpPr/>
          <p:nvPr/>
        </p:nvSpPr>
        <p:spPr>
          <a:xfrm>
            <a:off x="1717560" y="68436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R5U4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矩形 18"/>
          <p:cNvSpPr/>
          <p:nvPr/>
        </p:nvSpPr>
        <p:spPr>
          <a:xfrm>
            <a:off x="1711440" y="804960"/>
            <a:ext cx="76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G82K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矩形 21"/>
          <p:cNvSpPr/>
          <p:nvPr/>
        </p:nvSpPr>
        <p:spPr>
          <a:xfrm>
            <a:off x="1724760" y="554040"/>
            <a:ext cx="714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IH3S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矩形 31"/>
          <p:cNvSpPr/>
          <p:nvPr/>
        </p:nvSpPr>
        <p:spPr>
          <a:xfrm>
            <a:off x="1720440" y="965160"/>
            <a:ext cx="72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JB3H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矩形 32"/>
          <p:cNvSpPr/>
          <p:nvPr/>
        </p:nvSpPr>
        <p:spPr>
          <a:xfrm>
            <a:off x="1715400" y="109692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XQ7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右大括号 43"/>
          <p:cNvSpPr/>
          <p:nvPr/>
        </p:nvSpPr>
        <p:spPr>
          <a:xfrm>
            <a:off x="2714760" y="996840"/>
            <a:ext cx="142920" cy="252360"/>
          </a:xfrm>
          <a:custGeom>
            <a:avLst/>
            <a:gdLst>
              <a:gd name="textAreaLeft" fmla="*/ 0 w 142920"/>
              <a:gd name="textAreaRight" fmla="*/ 51480 w 142920"/>
              <a:gd name="textAreaTop" fmla="*/ 3600 h 252360"/>
              <a:gd name="textAreaBottom" fmla="*/ 248760 h 252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510"/>
                  <a:pt x="10800" y="1019"/>
                </a:cubicBezTo>
                <a:lnTo>
                  <a:pt x="10800" y="9781"/>
                </a:lnTo>
                <a:cubicBezTo>
                  <a:pt x="10800" y="10291"/>
                  <a:pt x="16200" y="10800"/>
                  <a:pt x="21600" y="10800"/>
                </a:cubicBezTo>
                <a:cubicBezTo>
                  <a:pt x="16200" y="10800"/>
                  <a:pt x="10800" y="11310"/>
                  <a:pt x="10800" y="11819"/>
                </a:cubicBezTo>
                <a:lnTo>
                  <a:pt x="10800" y="20581"/>
                </a:lnTo>
                <a:cubicBezTo>
                  <a:pt x="10800" y="21091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50"/>
          <p:cNvSpPr/>
          <p:nvPr/>
        </p:nvSpPr>
        <p:spPr>
          <a:xfrm>
            <a:off x="2789280" y="682560"/>
            <a:ext cx="698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R6OX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51"/>
          <p:cNvSpPr/>
          <p:nvPr/>
        </p:nvSpPr>
        <p:spPr>
          <a:xfrm>
            <a:off x="2793960" y="1017720"/>
            <a:ext cx="127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AS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右大括号 61"/>
          <p:cNvSpPr/>
          <p:nvPr/>
        </p:nvSpPr>
        <p:spPr>
          <a:xfrm>
            <a:off x="2719440" y="5384880"/>
            <a:ext cx="142920" cy="252360"/>
          </a:xfrm>
          <a:custGeom>
            <a:avLst/>
            <a:gdLst>
              <a:gd name="textAreaLeft" fmla="*/ 0 w 142920"/>
              <a:gd name="textAreaRight" fmla="*/ 51480 w 142920"/>
              <a:gd name="textAreaTop" fmla="*/ 3600 h 252360"/>
              <a:gd name="textAreaBottom" fmla="*/ 248760 h 2523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510"/>
                  <a:pt x="10800" y="1019"/>
                </a:cubicBezTo>
                <a:lnTo>
                  <a:pt x="10800" y="9781"/>
                </a:lnTo>
                <a:cubicBezTo>
                  <a:pt x="10800" y="10291"/>
                  <a:pt x="16200" y="10800"/>
                  <a:pt x="21600" y="10800"/>
                </a:cubicBezTo>
                <a:cubicBezTo>
                  <a:pt x="16200" y="10800"/>
                  <a:pt x="10800" y="11310"/>
                  <a:pt x="10800" y="11819"/>
                </a:cubicBezTo>
                <a:lnTo>
                  <a:pt x="10800" y="20581"/>
                </a:lnTo>
                <a:cubicBezTo>
                  <a:pt x="10800" y="21091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62"/>
          <p:cNvSpPr/>
          <p:nvPr/>
        </p:nvSpPr>
        <p:spPr>
          <a:xfrm>
            <a:off x="2793960" y="5408640"/>
            <a:ext cx="7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PLA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矩形 63"/>
          <p:cNvSpPr/>
          <p:nvPr/>
        </p:nvSpPr>
        <p:spPr>
          <a:xfrm>
            <a:off x="1737720" y="5324400"/>
            <a:ext cx="1061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GI_novel_G0040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矩形 64"/>
          <p:cNvSpPr/>
          <p:nvPr/>
        </p:nvSpPr>
        <p:spPr>
          <a:xfrm>
            <a:off x="1736640" y="546408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Y096Z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矩形 80"/>
          <p:cNvSpPr/>
          <p:nvPr/>
        </p:nvSpPr>
        <p:spPr>
          <a:xfrm>
            <a:off x="1709280" y="5638680"/>
            <a:ext cx="799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H2RV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矩形 82"/>
          <p:cNvSpPr/>
          <p:nvPr/>
        </p:nvSpPr>
        <p:spPr>
          <a:xfrm>
            <a:off x="1729800" y="5813280"/>
            <a:ext cx="759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FV6Y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矩形 83"/>
          <p:cNvSpPr/>
          <p:nvPr/>
        </p:nvSpPr>
        <p:spPr>
          <a:xfrm>
            <a:off x="1734840" y="5948280"/>
            <a:ext cx="74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F1ZZ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矩形 84"/>
          <p:cNvSpPr/>
          <p:nvPr/>
        </p:nvSpPr>
        <p:spPr>
          <a:xfrm>
            <a:off x="1729800" y="606744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0C0Y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矩形 85"/>
          <p:cNvSpPr/>
          <p:nvPr/>
        </p:nvSpPr>
        <p:spPr>
          <a:xfrm>
            <a:off x="1733400" y="6192720"/>
            <a:ext cx="743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22RG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矩形 90"/>
          <p:cNvSpPr/>
          <p:nvPr/>
        </p:nvSpPr>
        <p:spPr>
          <a:xfrm>
            <a:off x="1725120" y="6513480"/>
            <a:ext cx="72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M6X0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矩形 91"/>
          <p:cNvSpPr/>
          <p:nvPr/>
        </p:nvSpPr>
        <p:spPr>
          <a:xfrm>
            <a:off x="1723320" y="6638760"/>
            <a:ext cx="73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60KB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矩形 93"/>
          <p:cNvSpPr/>
          <p:nvPr/>
        </p:nvSpPr>
        <p:spPr>
          <a:xfrm>
            <a:off x="1725480" y="6384960"/>
            <a:ext cx="749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UPC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99"/>
          <p:cNvSpPr/>
          <p:nvPr/>
        </p:nvSpPr>
        <p:spPr>
          <a:xfrm>
            <a:off x="2803680" y="5637240"/>
            <a:ext cx="698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O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右大括号 101"/>
          <p:cNvSpPr/>
          <p:nvPr/>
        </p:nvSpPr>
        <p:spPr>
          <a:xfrm>
            <a:off x="2712960" y="5834160"/>
            <a:ext cx="142920" cy="503280"/>
          </a:xfrm>
          <a:custGeom>
            <a:avLst/>
            <a:gdLst>
              <a:gd name="textAreaLeft" fmla="*/ 0 w 142920"/>
              <a:gd name="textAreaRight" fmla="*/ 51480 w 142920"/>
              <a:gd name="textAreaTop" fmla="*/ 3600 h 503280"/>
              <a:gd name="textAreaBottom" fmla="*/ 499680 h 503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56"/>
                  <a:pt x="10800" y="511"/>
                </a:cubicBezTo>
                <a:lnTo>
                  <a:pt x="10800" y="10289"/>
                </a:lnTo>
                <a:cubicBezTo>
                  <a:pt x="10800" y="10545"/>
                  <a:pt x="16200" y="10800"/>
                  <a:pt x="21600" y="10800"/>
                </a:cubicBezTo>
                <a:cubicBezTo>
                  <a:pt x="16200" y="10800"/>
                  <a:pt x="10800" y="11056"/>
                  <a:pt x="10800" y="11311"/>
                </a:cubicBezTo>
                <a:lnTo>
                  <a:pt x="10800" y="21089"/>
                </a:lnTo>
                <a:cubicBezTo>
                  <a:pt x="10800" y="21345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102"/>
          <p:cNvSpPr/>
          <p:nvPr/>
        </p:nvSpPr>
        <p:spPr>
          <a:xfrm>
            <a:off x="2820960" y="5967360"/>
            <a:ext cx="7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OP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右大括号 105"/>
          <p:cNvSpPr/>
          <p:nvPr/>
        </p:nvSpPr>
        <p:spPr>
          <a:xfrm>
            <a:off x="2714760" y="6426360"/>
            <a:ext cx="142920" cy="377640"/>
          </a:xfrm>
          <a:custGeom>
            <a:avLst/>
            <a:gdLst>
              <a:gd name="textAreaLeft" fmla="*/ 0 w 142920"/>
              <a:gd name="textAreaRight" fmla="*/ 51480 w 142920"/>
              <a:gd name="textAreaTop" fmla="*/ 3600 h 377640"/>
              <a:gd name="textAreaBottom" fmla="*/ 374040 h 377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41"/>
                  <a:pt x="10800" y="681"/>
                </a:cubicBezTo>
                <a:lnTo>
                  <a:pt x="10800" y="10119"/>
                </a:lnTo>
                <a:cubicBezTo>
                  <a:pt x="10800" y="10460"/>
                  <a:pt x="16200" y="10800"/>
                  <a:pt x="21600" y="10800"/>
                </a:cubicBezTo>
                <a:cubicBezTo>
                  <a:pt x="16200" y="10800"/>
                  <a:pt x="10800" y="11141"/>
                  <a:pt x="10800" y="11481"/>
                </a:cubicBezTo>
                <a:lnTo>
                  <a:pt x="10800" y="20919"/>
                </a:lnTo>
                <a:cubicBezTo>
                  <a:pt x="10800" y="2126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106"/>
          <p:cNvSpPr/>
          <p:nvPr/>
        </p:nvSpPr>
        <p:spPr>
          <a:xfrm>
            <a:off x="2830680" y="6508800"/>
            <a:ext cx="699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MF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3" name="组合 107"/>
          <p:cNvGrpSpPr/>
          <p:nvPr/>
        </p:nvGrpSpPr>
        <p:grpSpPr>
          <a:xfrm>
            <a:off x="948240" y="6780240"/>
            <a:ext cx="840960" cy="830160"/>
            <a:chOff x="948240" y="6780240"/>
            <a:chExt cx="840960" cy="830160"/>
          </a:xfrm>
        </p:grpSpPr>
        <p:sp>
          <p:nvSpPr>
            <p:cNvPr id="84" name="文本框 155"/>
            <p:cNvSpPr/>
            <p:nvPr/>
          </p:nvSpPr>
          <p:spPr>
            <a:xfrm rot="5400000">
              <a:off x="644400" y="7083720"/>
              <a:ext cx="82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wsc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 DAF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文本框 156"/>
            <p:cNvSpPr/>
            <p:nvPr/>
          </p:nvSpPr>
          <p:spPr>
            <a:xfrm rot="5400000">
              <a:off x="777960" y="7087320"/>
              <a:ext cx="82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wsc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 DAF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文本框 157"/>
            <p:cNvSpPr/>
            <p:nvPr/>
          </p:nvSpPr>
          <p:spPr>
            <a:xfrm rot="5400000">
              <a:off x="882720" y="7091280"/>
              <a:ext cx="82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wsc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 DAF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文本框 158"/>
            <p:cNvSpPr/>
            <p:nvPr/>
          </p:nvSpPr>
          <p:spPr>
            <a:xfrm rot="5400000">
              <a:off x="991800" y="7087320"/>
              <a:ext cx="82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WT DAF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文本框 159"/>
            <p:cNvSpPr/>
            <p:nvPr/>
          </p:nvSpPr>
          <p:spPr>
            <a:xfrm rot="5400000">
              <a:off x="1146240" y="7086600"/>
              <a:ext cx="82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WT DAF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文本框 160"/>
            <p:cNvSpPr/>
            <p:nvPr/>
          </p:nvSpPr>
          <p:spPr>
            <a:xfrm rot="5400000">
              <a:off x="1270080" y="7086600"/>
              <a:ext cx="82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WT DAF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90" name="Picture 2" descr="F:\油料所工作\PLA10608.tif"/>
          <p:cNvPicPr/>
          <p:nvPr/>
        </p:nvPicPr>
        <p:blipFill>
          <a:blip r:embed="rId2"/>
          <a:stretch/>
        </p:blipFill>
        <p:spPr>
          <a:xfrm>
            <a:off x="312840" y="5365800"/>
            <a:ext cx="1477800" cy="285840"/>
          </a:xfrm>
          <a:prstGeom prst="rect">
            <a:avLst/>
          </a:prstGeom>
          <a:ln w="0">
            <a:noFill/>
          </a:ln>
        </p:spPr>
      </p:pic>
      <p:pic>
        <p:nvPicPr>
          <p:cNvPr id="91" name="Picture 3" descr="F:\油料所工作\AOC0608.tif"/>
          <p:cNvPicPr/>
          <p:nvPr/>
        </p:nvPicPr>
        <p:blipFill>
          <a:blip r:embed="rId3"/>
          <a:stretch/>
        </p:blipFill>
        <p:spPr>
          <a:xfrm>
            <a:off x="993600" y="5681520"/>
            <a:ext cx="771840" cy="13680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4" descr="F:\油料所工作\OPR0608.tif"/>
          <p:cNvPicPr/>
          <p:nvPr/>
        </p:nvPicPr>
        <p:blipFill>
          <a:blip r:embed="rId4"/>
          <a:stretch/>
        </p:blipFill>
        <p:spPr>
          <a:xfrm>
            <a:off x="336600" y="5843520"/>
            <a:ext cx="1463760" cy="55260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5" descr="F:\油料所工作\MFP20608.tif"/>
          <p:cNvPicPr/>
          <p:nvPr/>
        </p:nvPicPr>
        <p:blipFill>
          <a:blip r:embed="rId5"/>
          <a:stretch/>
        </p:blipFill>
        <p:spPr>
          <a:xfrm>
            <a:off x="326880" y="6405480"/>
            <a:ext cx="1463760" cy="44460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6" descr="F:\油料所工作\KAO0611.tif"/>
          <p:cNvPicPr/>
          <p:nvPr/>
        </p:nvPicPr>
        <p:blipFill>
          <a:blip r:embed="rId6"/>
          <a:stretch/>
        </p:blipFill>
        <p:spPr>
          <a:xfrm>
            <a:off x="298440" y="2119320"/>
            <a:ext cx="1477800" cy="42696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7" descr="F:\油料所工作\GA2ox0611.tif"/>
          <p:cNvPicPr/>
          <p:nvPr/>
        </p:nvPicPr>
        <p:blipFill>
          <a:blip r:embed="rId7"/>
          <a:stretch/>
        </p:blipFill>
        <p:spPr>
          <a:xfrm>
            <a:off x="304920" y="2556000"/>
            <a:ext cx="1481040" cy="41436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8" descr="F:\油料所工作\GA3ox0611.tif"/>
          <p:cNvPicPr/>
          <p:nvPr/>
        </p:nvPicPr>
        <p:blipFill>
          <a:blip r:embed="rId8"/>
          <a:stretch/>
        </p:blipFill>
        <p:spPr>
          <a:xfrm>
            <a:off x="996840" y="2995560"/>
            <a:ext cx="774720" cy="13644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9" descr="F:\油料所工作\GA20ox0611.tif"/>
          <p:cNvPicPr/>
          <p:nvPr/>
        </p:nvPicPr>
        <p:blipFill>
          <a:blip r:embed="rId9"/>
          <a:stretch/>
        </p:blipFill>
        <p:spPr>
          <a:xfrm>
            <a:off x="304920" y="3160800"/>
            <a:ext cx="1474560" cy="1191960"/>
          </a:xfrm>
          <a:prstGeom prst="rect">
            <a:avLst/>
          </a:prstGeom>
          <a:ln w="0">
            <a:noFill/>
          </a:ln>
        </p:spPr>
      </p:pic>
      <p:sp>
        <p:nvSpPr>
          <p:cNvPr id="98" name="矩形 118"/>
          <p:cNvSpPr/>
          <p:nvPr/>
        </p:nvSpPr>
        <p:spPr>
          <a:xfrm>
            <a:off x="1712160" y="2101680"/>
            <a:ext cx="74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BUI3V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矩形 119"/>
          <p:cNvSpPr/>
          <p:nvPr/>
        </p:nvSpPr>
        <p:spPr>
          <a:xfrm>
            <a:off x="1710720" y="2222640"/>
            <a:ext cx="80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62CW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矩形 120"/>
          <p:cNvSpPr/>
          <p:nvPr/>
        </p:nvSpPr>
        <p:spPr>
          <a:xfrm>
            <a:off x="1729440" y="2352600"/>
            <a:ext cx="77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FF0Q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矩形 121"/>
          <p:cNvSpPr/>
          <p:nvPr/>
        </p:nvSpPr>
        <p:spPr>
          <a:xfrm>
            <a:off x="1734840" y="2523960"/>
            <a:ext cx="777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KVM2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矩形 122"/>
          <p:cNvSpPr/>
          <p:nvPr/>
        </p:nvSpPr>
        <p:spPr>
          <a:xfrm>
            <a:off x="1728360" y="2654280"/>
            <a:ext cx="799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D1QW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矩形 123"/>
          <p:cNvSpPr/>
          <p:nvPr/>
        </p:nvSpPr>
        <p:spPr>
          <a:xfrm>
            <a:off x="1725840" y="2779560"/>
            <a:ext cx="72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8X7V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矩形 124"/>
          <p:cNvSpPr/>
          <p:nvPr/>
        </p:nvSpPr>
        <p:spPr>
          <a:xfrm>
            <a:off x="1737360" y="2940120"/>
            <a:ext cx="738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NS97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矩形 125"/>
          <p:cNvSpPr/>
          <p:nvPr/>
        </p:nvSpPr>
        <p:spPr>
          <a:xfrm>
            <a:off x="1735920" y="3138480"/>
            <a:ext cx="792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U5UG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矩形 126"/>
          <p:cNvSpPr/>
          <p:nvPr/>
        </p:nvSpPr>
        <p:spPr>
          <a:xfrm>
            <a:off x="1735560" y="3263760"/>
            <a:ext cx="74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H5TP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矩形 127"/>
          <p:cNvSpPr/>
          <p:nvPr/>
        </p:nvSpPr>
        <p:spPr>
          <a:xfrm>
            <a:off x="1732680" y="3392640"/>
            <a:ext cx="74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UXP0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矩形 128"/>
          <p:cNvSpPr/>
          <p:nvPr/>
        </p:nvSpPr>
        <p:spPr>
          <a:xfrm>
            <a:off x="1734480" y="352116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WBV2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矩形 129"/>
          <p:cNvSpPr/>
          <p:nvPr/>
        </p:nvSpPr>
        <p:spPr>
          <a:xfrm>
            <a:off x="1724760" y="3643200"/>
            <a:ext cx="744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2Y79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矩形 130"/>
          <p:cNvSpPr/>
          <p:nvPr/>
        </p:nvSpPr>
        <p:spPr>
          <a:xfrm>
            <a:off x="1728000" y="3765600"/>
            <a:ext cx="755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NT0E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矩形 131"/>
          <p:cNvSpPr/>
          <p:nvPr/>
        </p:nvSpPr>
        <p:spPr>
          <a:xfrm>
            <a:off x="1733040" y="3895560"/>
            <a:ext cx="1061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GI_novel_G0032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矩形 132"/>
          <p:cNvSpPr/>
          <p:nvPr/>
        </p:nvSpPr>
        <p:spPr>
          <a:xfrm>
            <a:off x="1740240" y="4017960"/>
            <a:ext cx="73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ip.0B6P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矩形 133"/>
          <p:cNvSpPr/>
          <p:nvPr/>
        </p:nvSpPr>
        <p:spPr>
          <a:xfrm>
            <a:off x="1729080" y="4157640"/>
            <a:ext cx="75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radu.UIA4U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右大括号 134"/>
          <p:cNvSpPr/>
          <p:nvPr/>
        </p:nvSpPr>
        <p:spPr>
          <a:xfrm>
            <a:off x="2759040" y="2147760"/>
            <a:ext cx="142920" cy="378000"/>
          </a:xfrm>
          <a:custGeom>
            <a:avLst/>
            <a:gdLst>
              <a:gd name="textAreaLeft" fmla="*/ 0 w 142920"/>
              <a:gd name="textAreaRight" fmla="*/ 51480 w 142920"/>
              <a:gd name="textAreaTop" fmla="*/ 3600 h 378000"/>
              <a:gd name="textAreaBottom" fmla="*/ 374400 h 37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41"/>
                  <a:pt x="10800" y="681"/>
                </a:cubicBezTo>
                <a:lnTo>
                  <a:pt x="10800" y="10119"/>
                </a:lnTo>
                <a:cubicBezTo>
                  <a:pt x="10800" y="10460"/>
                  <a:pt x="16200" y="10800"/>
                  <a:pt x="21600" y="10800"/>
                </a:cubicBezTo>
                <a:cubicBezTo>
                  <a:pt x="16200" y="10800"/>
                  <a:pt x="10800" y="11141"/>
                  <a:pt x="10800" y="11481"/>
                </a:cubicBezTo>
                <a:lnTo>
                  <a:pt x="10800" y="20919"/>
                </a:lnTo>
                <a:cubicBezTo>
                  <a:pt x="10800" y="2126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135"/>
          <p:cNvSpPr/>
          <p:nvPr/>
        </p:nvSpPr>
        <p:spPr>
          <a:xfrm>
            <a:off x="2824200" y="2238480"/>
            <a:ext cx="7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KA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右大括号 136"/>
          <p:cNvSpPr/>
          <p:nvPr/>
        </p:nvSpPr>
        <p:spPr>
          <a:xfrm>
            <a:off x="2759040" y="2576520"/>
            <a:ext cx="142920" cy="377640"/>
          </a:xfrm>
          <a:custGeom>
            <a:avLst/>
            <a:gdLst>
              <a:gd name="textAreaLeft" fmla="*/ 0 w 142920"/>
              <a:gd name="textAreaRight" fmla="*/ 51480 w 142920"/>
              <a:gd name="textAreaTop" fmla="*/ 3600 h 377640"/>
              <a:gd name="textAreaBottom" fmla="*/ 374040 h 377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341"/>
                  <a:pt x="10800" y="681"/>
                </a:cubicBezTo>
                <a:lnTo>
                  <a:pt x="10800" y="10119"/>
                </a:lnTo>
                <a:cubicBezTo>
                  <a:pt x="10800" y="10460"/>
                  <a:pt x="16200" y="10800"/>
                  <a:pt x="21600" y="10800"/>
                </a:cubicBezTo>
                <a:cubicBezTo>
                  <a:pt x="16200" y="10800"/>
                  <a:pt x="10800" y="11141"/>
                  <a:pt x="10800" y="11481"/>
                </a:cubicBezTo>
                <a:lnTo>
                  <a:pt x="10800" y="20919"/>
                </a:lnTo>
                <a:cubicBezTo>
                  <a:pt x="10800" y="2126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137"/>
          <p:cNvSpPr/>
          <p:nvPr/>
        </p:nvSpPr>
        <p:spPr>
          <a:xfrm>
            <a:off x="2824200" y="2666880"/>
            <a:ext cx="7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GA2o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138"/>
          <p:cNvSpPr/>
          <p:nvPr/>
        </p:nvSpPr>
        <p:spPr>
          <a:xfrm>
            <a:off x="2827440" y="2925720"/>
            <a:ext cx="699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GA3o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右大括号 139"/>
          <p:cNvSpPr/>
          <p:nvPr/>
        </p:nvSpPr>
        <p:spPr>
          <a:xfrm>
            <a:off x="2754360" y="3189240"/>
            <a:ext cx="142920" cy="1133640"/>
          </a:xfrm>
          <a:custGeom>
            <a:avLst/>
            <a:gdLst>
              <a:gd name="textAreaLeft" fmla="*/ 0 w 142920"/>
              <a:gd name="textAreaRight" fmla="*/ 51480 w 142920"/>
              <a:gd name="textAreaTop" fmla="*/ 3600 h 1133640"/>
              <a:gd name="textAreaBottom" fmla="*/ 1130040 h 11336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114"/>
                  <a:pt x="10800" y="227"/>
                </a:cubicBezTo>
                <a:lnTo>
                  <a:pt x="10800" y="10573"/>
                </a:lnTo>
                <a:cubicBezTo>
                  <a:pt x="10800" y="10687"/>
                  <a:pt x="16200" y="10800"/>
                  <a:pt x="21600" y="10800"/>
                </a:cubicBezTo>
                <a:cubicBezTo>
                  <a:pt x="16200" y="10800"/>
                  <a:pt x="10800" y="10914"/>
                  <a:pt x="10800" y="11027"/>
                </a:cubicBezTo>
                <a:lnTo>
                  <a:pt x="10800" y="21373"/>
                </a:lnTo>
                <a:cubicBezTo>
                  <a:pt x="10800" y="21487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140"/>
          <p:cNvSpPr/>
          <p:nvPr/>
        </p:nvSpPr>
        <p:spPr>
          <a:xfrm>
            <a:off x="2820960" y="3651120"/>
            <a:ext cx="698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GA20o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1" name="组合 141"/>
          <p:cNvGrpSpPr/>
          <p:nvPr/>
        </p:nvGrpSpPr>
        <p:grpSpPr>
          <a:xfrm>
            <a:off x="967320" y="4273560"/>
            <a:ext cx="840960" cy="830160"/>
            <a:chOff x="967320" y="4273560"/>
            <a:chExt cx="840960" cy="830160"/>
          </a:xfrm>
        </p:grpSpPr>
        <p:sp>
          <p:nvSpPr>
            <p:cNvPr id="122" name="文本框 155"/>
            <p:cNvSpPr/>
            <p:nvPr/>
          </p:nvSpPr>
          <p:spPr>
            <a:xfrm rot="5400000">
              <a:off x="663480" y="4577040"/>
              <a:ext cx="82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wsc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 DAF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文本框 156"/>
            <p:cNvSpPr/>
            <p:nvPr/>
          </p:nvSpPr>
          <p:spPr>
            <a:xfrm rot="5400000">
              <a:off x="797040" y="4580640"/>
              <a:ext cx="82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wsc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 DAF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文本框 157"/>
            <p:cNvSpPr/>
            <p:nvPr/>
          </p:nvSpPr>
          <p:spPr>
            <a:xfrm rot="5400000">
              <a:off x="901800" y="4584600"/>
              <a:ext cx="82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Times New Roman"/>
                </a:rPr>
                <a:t>wsc</a:t>
              </a: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 DAF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文本框 158"/>
            <p:cNvSpPr/>
            <p:nvPr/>
          </p:nvSpPr>
          <p:spPr>
            <a:xfrm rot="5400000">
              <a:off x="1010880" y="4580640"/>
              <a:ext cx="82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WT DAF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文本框 159"/>
            <p:cNvSpPr/>
            <p:nvPr/>
          </p:nvSpPr>
          <p:spPr>
            <a:xfrm rot="5400000">
              <a:off x="1152000" y="4579920"/>
              <a:ext cx="82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WT DAF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文本框 160"/>
            <p:cNvSpPr/>
            <p:nvPr/>
          </p:nvSpPr>
          <p:spPr>
            <a:xfrm rot="5400000">
              <a:off x="1289160" y="4579920"/>
              <a:ext cx="822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WT DAF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128" name="Picture 10" descr="F:\油料所工作\BR6OX10611.tif"/>
          <p:cNvPicPr/>
          <p:nvPr/>
        </p:nvPicPr>
        <p:blipFill>
          <a:blip r:embed="rId10"/>
          <a:stretch/>
        </p:blipFill>
        <p:spPr>
          <a:xfrm>
            <a:off x="330120" y="608040"/>
            <a:ext cx="1481040" cy="399960"/>
          </a:xfrm>
          <a:prstGeom prst="rect">
            <a:avLst/>
          </a:prstGeom>
          <a:ln w="0">
            <a:noFill/>
          </a:ln>
        </p:spPr>
      </p:pic>
      <p:sp>
        <p:nvSpPr>
          <p:cNvPr id="129" name="TextBox 150"/>
          <p:cNvSpPr/>
          <p:nvPr/>
        </p:nvSpPr>
        <p:spPr>
          <a:xfrm>
            <a:off x="30240" y="181440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151"/>
          <p:cNvSpPr/>
          <p:nvPr/>
        </p:nvSpPr>
        <p:spPr>
          <a:xfrm>
            <a:off x="30240" y="503064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1" name="图表 88" descr=""/>
          <p:cNvPicPr/>
          <p:nvPr/>
        </p:nvPicPr>
        <p:blipFill>
          <a:blip r:embed="rId11"/>
          <a:stretch/>
        </p:blipFill>
        <p:spPr>
          <a:xfrm>
            <a:off x="3382920" y="1785960"/>
            <a:ext cx="1401840" cy="1785960"/>
          </a:xfrm>
          <a:prstGeom prst="rect">
            <a:avLst/>
          </a:prstGeom>
          <a:ln w="0">
            <a:noFill/>
          </a:ln>
        </p:spPr>
      </p:pic>
      <p:pic>
        <p:nvPicPr>
          <p:cNvPr id="132" name="图表 89" descr=""/>
          <p:cNvPicPr/>
          <p:nvPr/>
        </p:nvPicPr>
        <p:blipFill>
          <a:blip r:embed="rId12"/>
          <a:stretch/>
        </p:blipFill>
        <p:spPr>
          <a:xfrm>
            <a:off x="4711680" y="1865160"/>
            <a:ext cx="1201680" cy="1700280"/>
          </a:xfrm>
          <a:prstGeom prst="rect">
            <a:avLst/>
          </a:prstGeom>
          <a:ln w="0">
            <a:noFill/>
          </a:ln>
        </p:spPr>
      </p:pic>
      <p:sp>
        <p:nvSpPr>
          <p:cNvPr id="133" name="TextBox 92"/>
          <p:cNvSpPr/>
          <p:nvPr/>
        </p:nvSpPr>
        <p:spPr>
          <a:xfrm rot="16200000">
            <a:off x="2973240" y="3544560"/>
            <a:ext cx="7635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94"/>
          <p:cNvSpPr/>
          <p:nvPr/>
        </p:nvSpPr>
        <p:spPr>
          <a:xfrm rot="16200000">
            <a:off x="2889000" y="2079720"/>
            <a:ext cx="906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矩形 96"/>
          <p:cNvSpPr/>
          <p:nvPr/>
        </p:nvSpPr>
        <p:spPr>
          <a:xfrm>
            <a:off x="3870720" y="1979640"/>
            <a:ext cx="38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KA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6" name="图表 97" descr=""/>
          <p:cNvPicPr/>
          <p:nvPr/>
        </p:nvPicPr>
        <p:blipFill>
          <a:blip r:embed="rId13"/>
          <a:stretch/>
        </p:blipFill>
        <p:spPr>
          <a:xfrm>
            <a:off x="5950080" y="1712880"/>
            <a:ext cx="761760" cy="1816200"/>
          </a:xfrm>
          <a:prstGeom prst="rect">
            <a:avLst/>
          </a:prstGeom>
          <a:ln w="0">
            <a:noFill/>
          </a:ln>
        </p:spPr>
      </p:pic>
      <p:sp>
        <p:nvSpPr>
          <p:cNvPr id="137" name="TextBox 98"/>
          <p:cNvSpPr/>
          <p:nvPr/>
        </p:nvSpPr>
        <p:spPr>
          <a:xfrm>
            <a:off x="5213520" y="1979640"/>
            <a:ext cx="698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GA2o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Box 100"/>
          <p:cNvSpPr/>
          <p:nvPr/>
        </p:nvSpPr>
        <p:spPr>
          <a:xfrm>
            <a:off x="6151680" y="1911240"/>
            <a:ext cx="698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GA3o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9" name="图表 103" descr=""/>
          <p:cNvPicPr/>
          <p:nvPr/>
        </p:nvPicPr>
        <p:blipFill>
          <a:blip r:embed="rId14"/>
          <a:stretch/>
        </p:blipFill>
        <p:spPr>
          <a:xfrm>
            <a:off x="3309840" y="3425760"/>
            <a:ext cx="3481560" cy="1719360"/>
          </a:xfrm>
          <a:prstGeom prst="rect">
            <a:avLst/>
          </a:prstGeom>
          <a:ln w="0">
            <a:noFill/>
          </a:ln>
        </p:spPr>
      </p:pic>
      <p:sp>
        <p:nvSpPr>
          <p:cNvPr id="140" name="TextBox 104"/>
          <p:cNvSpPr/>
          <p:nvPr/>
        </p:nvSpPr>
        <p:spPr>
          <a:xfrm>
            <a:off x="4699080" y="3635280"/>
            <a:ext cx="699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GA20o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1" name="图表 114" descr=""/>
          <p:cNvPicPr/>
          <p:nvPr/>
        </p:nvPicPr>
        <p:blipFill>
          <a:blip r:embed="rId15"/>
          <a:stretch/>
        </p:blipFill>
        <p:spPr>
          <a:xfrm>
            <a:off x="3413160" y="5114880"/>
            <a:ext cx="1573200" cy="1285920"/>
          </a:xfrm>
          <a:prstGeom prst="rect">
            <a:avLst/>
          </a:prstGeom>
          <a:ln w="0">
            <a:noFill/>
          </a:ln>
        </p:spPr>
      </p:pic>
      <p:sp>
        <p:nvSpPr>
          <p:cNvPr id="142" name="TextBox 115"/>
          <p:cNvSpPr/>
          <p:nvPr/>
        </p:nvSpPr>
        <p:spPr>
          <a:xfrm rot="16200000">
            <a:off x="2895120" y="5487840"/>
            <a:ext cx="906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3" name="图表 116" descr=""/>
          <p:cNvPicPr/>
          <p:nvPr/>
        </p:nvPicPr>
        <p:blipFill>
          <a:blip r:embed="rId16"/>
          <a:stretch/>
        </p:blipFill>
        <p:spPr>
          <a:xfrm>
            <a:off x="3462480" y="6724800"/>
            <a:ext cx="1212840" cy="1296720"/>
          </a:xfrm>
          <a:prstGeom prst="rect">
            <a:avLst/>
          </a:prstGeom>
          <a:ln w="0">
            <a:noFill/>
          </a:ln>
        </p:spPr>
      </p:pic>
      <p:sp>
        <p:nvSpPr>
          <p:cNvPr id="144" name="TextBox 117"/>
          <p:cNvSpPr/>
          <p:nvPr/>
        </p:nvSpPr>
        <p:spPr>
          <a:xfrm rot="16200000">
            <a:off x="2931840" y="6883560"/>
            <a:ext cx="906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5" name="图表 148" descr=""/>
          <p:cNvPicPr/>
          <p:nvPr/>
        </p:nvPicPr>
        <p:blipFill>
          <a:blip r:embed="rId17"/>
          <a:stretch/>
        </p:blipFill>
        <p:spPr>
          <a:xfrm>
            <a:off x="4505400" y="6718320"/>
            <a:ext cx="2359080" cy="1285920"/>
          </a:xfrm>
          <a:prstGeom prst="rect">
            <a:avLst/>
          </a:prstGeom>
          <a:ln w="0">
            <a:noFill/>
          </a:ln>
        </p:spPr>
      </p:pic>
      <p:sp>
        <p:nvSpPr>
          <p:cNvPr id="146" name="TextBox 152"/>
          <p:cNvSpPr/>
          <p:nvPr/>
        </p:nvSpPr>
        <p:spPr>
          <a:xfrm>
            <a:off x="4073400" y="6915240"/>
            <a:ext cx="7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AO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153"/>
          <p:cNvSpPr/>
          <p:nvPr/>
        </p:nvSpPr>
        <p:spPr>
          <a:xfrm>
            <a:off x="4060800" y="5305320"/>
            <a:ext cx="7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PLA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8" name="图表 154" descr=""/>
          <p:cNvPicPr/>
          <p:nvPr/>
        </p:nvPicPr>
        <p:blipFill>
          <a:blip r:embed="rId18"/>
          <a:stretch/>
        </p:blipFill>
        <p:spPr>
          <a:xfrm>
            <a:off x="4809960" y="5121360"/>
            <a:ext cx="1998720" cy="1285920"/>
          </a:xfrm>
          <a:prstGeom prst="rect">
            <a:avLst/>
          </a:prstGeom>
          <a:ln w="0">
            <a:noFill/>
          </a:ln>
        </p:spPr>
      </p:pic>
      <p:sp>
        <p:nvSpPr>
          <p:cNvPr id="149" name="TextBox 155"/>
          <p:cNvSpPr/>
          <p:nvPr/>
        </p:nvSpPr>
        <p:spPr>
          <a:xfrm>
            <a:off x="5111640" y="5322960"/>
            <a:ext cx="7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MF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0" name="图表 157" descr=""/>
          <p:cNvPicPr/>
          <p:nvPr/>
        </p:nvPicPr>
        <p:blipFill>
          <a:blip r:embed="rId19"/>
          <a:stretch/>
        </p:blipFill>
        <p:spPr>
          <a:xfrm>
            <a:off x="3438360" y="285840"/>
            <a:ext cx="1998720" cy="1427040"/>
          </a:xfrm>
          <a:prstGeom prst="rect">
            <a:avLst/>
          </a:prstGeom>
          <a:ln w="0">
            <a:noFill/>
          </a:ln>
        </p:spPr>
      </p:pic>
      <p:pic>
        <p:nvPicPr>
          <p:cNvPr id="151" name="图表 158" descr=""/>
          <p:cNvPicPr/>
          <p:nvPr/>
        </p:nvPicPr>
        <p:blipFill>
          <a:blip r:embed="rId20"/>
          <a:stretch/>
        </p:blipFill>
        <p:spPr>
          <a:xfrm>
            <a:off x="5218200" y="212760"/>
            <a:ext cx="1530360" cy="1414440"/>
          </a:xfrm>
          <a:prstGeom prst="rect">
            <a:avLst/>
          </a:prstGeom>
          <a:ln w="0">
            <a:noFill/>
          </a:ln>
        </p:spPr>
      </p:pic>
      <p:sp>
        <p:nvSpPr>
          <p:cNvPr id="152" name="TextBox 159"/>
          <p:cNvSpPr/>
          <p:nvPr/>
        </p:nvSpPr>
        <p:spPr>
          <a:xfrm rot="16200000">
            <a:off x="2894400" y="588240"/>
            <a:ext cx="8985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</a:rPr>
              <a:t>FPKM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3" name="组合 173"/>
          <p:cNvGrpSpPr/>
          <p:nvPr/>
        </p:nvGrpSpPr>
        <p:grpSpPr>
          <a:xfrm>
            <a:off x="2927520" y="4357800"/>
            <a:ext cx="438120" cy="941400"/>
            <a:chOff x="2927520" y="4357800"/>
            <a:chExt cx="438120" cy="941400"/>
          </a:xfrm>
        </p:grpSpPr>
        <p:pic>
          <p:nvPicPr>
            <p:cNvPr id="154" name="Picture 84" descr="F:\油料所工作\bar.tif"/>
            <p:cNvPicPr/>
            <p:nvPr/>
          </p:nvPicPr>
          <p:blipFill>
            <a:blip r:embed="rId21"/>
            <a:srcRect l="0" t="0" r="41333" b="0"/>
            <a:stretch/>
          </p:blipFill>
          <p:spPr>
            <a:xfrm>
              <a:off x="2927520" y="4362120"/>
              <a:ext cx="95040" cy="90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55" name="TextBox 192"/>
            <p:cNvSpPr/>
            <p:nvPr/>
          </p:nvSpPr>
          <p:spPr>
            <a:xfrm>
              <a:off x="2977920" y="4357800"/>
              <a:ext cx="382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Max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TextBox 195"/>
            <p:cNvSpPr/>
            <p:nvPr/>
          </p:nvSpPr>
          <p:spPr>
            <a:xfrm>
              <a:off x="2984760" y="5083560"/>
              <a:ext cx="380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Times New Roman"/>
                </a:rPr>
                <a:t>M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57" name="TextBox 50"/>
          <p:cNvSpPr/>
          <p:nvPr/>
        </p:nvSpPr>
        <p:spPr>
          <a:xfrm>
            <a:off x="4662360" y="341280"/>
            <a:ext cx="698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R6OX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Box 51"/>
          <p:cNvSpPr/>
          <p:nvPr/>
        </p:nvSpPr>
        <p:spPr>
          <a:xfrm>
            <a:off x="6202440" y="326880"/>
            <a:ext cx="127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BAS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文本框 1"/>
          <p:cNvSpPr/>
          <p:nvPr/>
        </p:nvSpPr>
        <p:spPr>
          <a:xfrm rot="5400000">
            <a:off x="3463920" y="4632840"/>
            <a:ext cx="6224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0B6PB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文本框 115"/>
          <p:cNvSpPr/>
          <p:nvPr/>
        </p:nvSpPr>
        <p:spPr>
          <a:xfrm rot="5400000">
            <a:off x="3752640" y="462888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2Y79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文本框 117"/>
          <p:cNvSpPr/>
          <p:nvPr/>
        </p:nvSpPr>
        <p:spPr>
          <a:xfrm rot="5400000">
            <a:off x="4040640" y="4628160"/>
            <a:ext cx="6224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NT0E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文本框 118"/>
          <p:cNvSpPr/>
          <p:nvPr/>
        </p:nvSpPr>
        <p:spPr>
          <a:xfrm rot="5400000">
            <a:off x="4356720" y="4631400"/>
            <a:ext cx="6224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WBV2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文本框 119"/>
          <p:cNvSpPr/>
          <p:nvPr/>
        </p:nvSpPr>
        <p:spPr>
          <a:xfrm rot="5400000">
            <a:off x="4659120" y="462564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H5TPY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文本框 120"/>
          <p:cNvSpPr/>
          <p:nvPr/>
        </p:nvSpPr>
        <p:spPr>
          <a:xfrm rot="5400000">
            <a:off x="4956840" y="4620240"/>
            <a:ext cx="6224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UIA4U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文本框 121"/>
          <p:cNvSpPr/>
          <p:nvPr/>
        </p:nvSpPr>
        <p:spPr>
          <a:xfrm rot="5400000">
            <a:off x="5263560" y="462744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UXP0Y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文本框 122"/>
          <p:cNvSpPr/>
          <p:nvPr/>
        </p:nvSpPr>
        <p:spPr>
          <a:xfrm rot="5400000">
            <a:off x="5454360" y="4735440"/>
            <a:ext cx="8395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GI_novel_G00322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文本框 123"/>
          <p:cNvSpPr/>
          <p:nvPr/>
        </p:nvSpPr>
        <p:spPr>
          <a:xfrm rot="5400000">
            <a:off x="5879880" y="463680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5DJ69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文本框 124"/>
          <p:cNvSpPr/>
          <p:nvPr/>
        </p:nvSpPr>
        <p:spPr>
          <a:xfrm rot="5400000">
            <a:off x="6181560" y="463356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U5UGY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文本框 125"/>
          <p:cNvSpPr/>
          <p:nvPr/>
        </p:nvSpPr>
        <p:spPr>
          <a:xfrm rot="5400000">
            <a:off x="3492360" y="321912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62CWM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文本框 126"/>
          <p:cNvSpPr/>
          <p:nvPr/>
        </p:nvSpPr>
        <p:spPr>
          <a:xfrm rot="5400000">
            <a:off x="3861360" y="3213720"/>
            <a:ext cx="6224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FF0QL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文本框 127"/>
          <p:cNvSpPr/>
          <p:nvPr/>
        </p:nvSpPr>
        <p:spPr>
          <a:xfrm rot="5400000">
            <a:off x="4189320" y="320976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BUI3V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文本框 128"/>
          <p:cNvSpPr/>
          <p:nvPr/>
        </p:nvSpPr>
        <p:spPr>
          <a:xfrm rot="5400000">
            <a:off x="3592440" y="164268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R5U41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文本框 129"/>
          <p:cNvSpPr/>
          <p:nvPr/>
        </p:nvSpPr>
        <p:spPr>
          <a:xfrm rot="5400000">
            <a:off x="4102200" y="1656360"/>
            <a:ext cx="6224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G82K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文本框 130"/>
          <p:cNvSpPr/>
          <p:nvPr/>
        </p:nvSpPr>
        <p:spPr>
          <a:xfrm rot="5400000">
            <a:off x="4620600" y="165564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IH3SP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文本框 131"/>
          <p:cNvSpPr/>
          <p:nvPr/>
        </p:nvSpPr>
        <p:spPr>
          <a:xfrm rot="5400000">
            <a:off x="5498280" y="1661400"/>
            <a:ext cx="6444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JB3H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文本框 132"/>
          <p:cNvSpPr/>
          <p:nvPr/>
        </p:nvSpPr>
        <p:spPr>
          <a:xfrm rot="5400000">
            <a:off x="6031440" y="1668960"/>
            <a:ext cx="6476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XQ725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文本框 133"/>
          <p:cNvSpPr/>
          <p:nvPr/>
        </p:nvSpPr>
        <p:spPr>
          <a:xfrm rot="5400000">
            <a:off x="4813920" y="3186720"/>
            <a:ext cx="6224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KVM2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文本框 135"/>
          <p:cNvSpPr/>
          <p:nvPr/>
        </p:nvSpPr>
        <p:spPr>
          <a:xfrm rot="5400000">
            <a:off x="5107680" y="3191400"/>
            <a:ext cx="6224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D1QW8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文本框 137"/>
          <p:cNvSpPr/>
          <p:nvPr/>
        </p:nvSpPr>
        <p:spPr>
          <a:xfrm rot="5400000">
            <a:off x="5373000" y="319068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8X7VT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文本框 138"/>
          <p:cNvSpPr/>
          <p:nvPr/>
        </p:nvSpPr>
        <p:spPr>
          <a:xfrm rot="5400000">
            <a:off x="6091200" y="317484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NS97H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文本框 140"/>
          <p:cNvSpPr/>
          <p:nvPr/>
        </p:nvSpPr>
        <p:spPr>
          <a:xfrm rot="5400000">
            <a:off x="3561480" y="6462000"/>
            <a:ext cx="7682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GI_novel_G00401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文本框 141"/>
          <p:cNvSpPr/>
          <p:nvPr/>
        </p:nvSpPr>
        <p:spPr>
          <a:xfrm rot="5400000">
            <a:off x="4262400" y="638964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Y096Z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文本框 142"/>
          <p:cNvSpPr/>
          <p:nvPr/>
        </p:nvSpPr>
        <p:spPr>
          <a:xfrm rot="5400000">
            <a:off x="5001480" y="6401520"/>
            <a:ext cx="622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M6X0I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文本框 143"/>
          <p:cNvSpPr/>
          <p:nvPr/>
        </p:nvSpPr>
        <p:spPr>
          <a:xfrm rot="5400000">
            <a:off x="5554080" y="6401520"/>
            <a:ext cx="622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UPC07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文本框 144"/>
          <p:cNvSpPr/>
          <p:nvPr/>
        </p:nvSpPr>
        <p:spPr>
          <a:xfrm rot="5400000">
            <a:off x="6105240" y="640692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60KBF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文本框 145"/>
          <p:cNvSpPr/>
          <p:nvPr/>
        </p:nvSpPr>
        <p:spPr>
          <a:xfrm rot="5400000">
            <a:off x="3807720" y="8051040"/>
            <a:ext cx="6220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H2RVW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文本框 146"/>
          <p:cNvSpPr/>
          <p:nvPr/>
        </p:nvSpPr>
        <p:spPr>
          <a:xfrm rot="5400000">
            <a:off x="4659840" y="8057160"/>
            <a:ext cx="62244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0C0YF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文本框 147"/>
          <p:cNvSpPr/>
          <p:nvPr/>
        </p:nvSpPr>
        <p:spPr>
          <a:xfrm rot="5400000">
            <a:off x="5173560" y="804996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du.FV6YV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文本框 149"/>
          <p:cNvSpPr/>
          <p:nvPr/>
        </p:nvSpPr>
        <p:spPr>
          <a:xfrm rot="5400000">
            <a:off x="5678280" y="805644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22RGE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文本框 150"/>
          <p:cNvSpPr/>
          <p:nvPr/>
        </p:nvSpPr>
        <p:spPr>
          <a:xfrm rot="5400000">
            <a:off x="6176880" y="8062560"/>
            <a:ext cx="623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raip.F1ZZD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Box 149"/>
          <p:cNvSpPr/>
          <p:nvPr/>
        </p:nvSpPr>
        <p:spPr>
          <a:xfrm>
            <a:off x="5457960" y="6961320"/>
            <a:ext cx="699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Times New Roman"/>
              </a:rPr>
              <a:t>OP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Box 1"/>
          <p:cNvSpPr/>
          <p:nvPr/>
        </p:nvSpPr>
        <p:spPr>
          <a:xfrm>
            <a:off x="3809880" y="336600"/>
            <a:ext cx="4906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F20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Box 146"/>
          <p:cNvSpPr/>
          <p:nvPr/>
        </p:nvSpPr>
        <p:spPr>
          <a:xfrm>
            <a:off x="4229280" y="343080"/>
            <a:ext cx="4888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F40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Box 147"/>
          <p:cNvSpPr/>
          <p:nvPr/>
        </p:nvSpPr>
        <p:spPr>
          <a:xfrm>
            <a:off x="3819600" y="428760"/>
            <a:ext cx="490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F60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Box 149"/>
          <p:cNvSpPr/>
          <p:nvPr/>
        </p:nvSpPr>
        <p:spPr>
          <a:xfrm>
            <a:off x="4233960" y="438120"/>
            <a:ext cx="4903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T</a:t>
            </a: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F20</a:t>
            </a: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Box 2"/>
          <p:cNvSpPr/>
          <p:nvPr/>
        </p:nvSpPr>
        <p:spPr>
          <a:xfrm>
            <a:off x="3817800" y="527040"/>
            <a:ext cx="60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T DAF40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矩形 1"/>
          <p:cNvSpPr/>
          <p:nvPr/>
        </p:nvSpPr>
        <p:spPr>
          <a:xfrm>
            <a:off x="49320" y="7440480"/>
            <a:ext cx="6980040" cy="161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6. The expression of phytohormone-synthesis pathway ge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WT. (A) Heatmap and FPKM values of differen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ed BR synthesis pathway genes between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WT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 Heatmap and FPKM values of the differently expressed GA synthe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athway genes between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 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d WT. (C) Heatmap and FPKM values of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ifferently expressed JA synthesis pathway genes between </a:t>
            </a:r>
            <a:r>
              <a:rPr b="0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WT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6OX1, brassinosteroid-6-oxidase 1; BAS1, PHYB-4 ACTIVATION-TAGGED SUPPRESSOR 1; KAO, ent-kaurenoic acid hydroxylase; GA2ox, gibberellin 2-oxidase; GA3ox, gibberellin 3-beta-dioxygenase; PLA1, phospholipase A1; AOC, allene oxide cyclase; OPR, 12-oxophytodienoic acid reductase; MFP2: multifunctional protein 2. The gene expression was scaled using Z-score of FPKM (mean value of three biological replications) in the heatmap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9-19T23:39:19Z</dcterms:created>
  <dc:creator>万丽云</dc:creator>
  <dc:description/>
  <dc:language>en-US</dc:language>
  <cp:lastModifiedBy>wly</cp:lastModifiedBy>
  <dcterms:modified xsi:type="dcterms:W3CDTF">2019-07-10T01:26:10Z</dcterms:modified>
  <cp:revision>29</cp:revision>
  <dc:subject/>
  <dc:title>幻灯片 1</dc:title>
</cp:coreProperties>
</file>